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C1350-0C40-41FC-9C8D-35075808E2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34B4A-5226-46F4-AD6B-635C384781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78159B-1AAE-4527-8244-E307B0A4DA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A7E3D-5266-4141-93E9-A49CEE630D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42B29-8EA0-4814-8C5F-AE5AF19788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885A2-864D-4408-B37B-6A9944D54A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64FDB-6D04-4DE4-BFCE-0C69808F37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D4A67-76D2-4136-B8CF-0C1727D87F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7998B-4E42-4145-A073-1D16C84CB2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2D2FE-D265-4B5E-8867-F9E69030E1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892F3-D4D6-4F12-AFFD-E1C518D749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78186-2364-4C4B-A906-F65B6A0C7D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8E3556-E786-4F21-ABA9-DA6BBA26D56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png"/><Relationship Id="rId7" Type="http://schemas.openxmlformats.org/officeDocument/2006/relationships/image" Target="../media/image4.jpeg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50158" t="50091" r="0" b="0"/>
          <a:stretch/>
        </p:blipFill>
        <p:spPr>
          <a:xfrm>
            <a:off x="3421080" y="2003400"/>
            <a:ext cx="1079640" cy="99684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50091" r="50158" b="0"/>
          <a:stretch/>
        </p:blipFill>
        <p:spPr>
          <a:xfrm>
            <a:off x="2335320" y="1019160"/>
            <a:ext cx="1079280" cy="9954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50006" t="0" r="0" b="49746"/>
          <a:stretch/>
        </p:blipFill>
        <p:spPr>
          <a:xfrm>
            <a:off x="3411360" y="1000080"/>
            <a:ext cx="1079640" cy="9968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0" t="0" r="50158" b="50091"/>
          <a:stretch/>
        </p:blipFill>
        <p:spPr>
          <a:xfrm>
            <a:off x="2335320" y="1986120"/>
            <a:ext cx="1079280" cy="9950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954160" y="1009800"/>
            <a:ext cx="503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34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989520" y="1009800"/>
            <a:ext cx="528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51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976480" y="1996920"/>
            <a:ext cx="48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99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005360" y="1996920"/>
            <a:ext cx="61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42 gen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444400" y="711360"/>
            <a:ext cx="194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HRG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</a:rPr>
              <a:t>k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-means cluster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52760" y="2050920"/>
            <a:ext cx="352440" cy="55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392200" y="2043000"/>
            <a:ext cx="352440" cy="55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379600" y="1063800"/>
            <a:ext cx="352440" cy="5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446640" y="1069920"/>
            <a:ext cx="352080" cy="55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310480" y="1008000"/>
            <a:ext cx="2538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377160" y="1008000"/>
            <a:ext cx="275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309760" y="2001960"/>
            <a:ext cx="296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ii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377160" y="1992240"/>
            <a:ext cx="291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Times New Roman"/>
              </a:rPr>
              <a:t>(iv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2252160" y="2796840"/>
            <a:ext cx="30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2332800" y="2768040"/>
            <a:ext cx="368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H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2461320" y="2754360"/>
            <a:ext cx="400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H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2616840" y="2754360"/>
            <a:ext cx="400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H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2822400" y="2802960"/>
            <a:ext cx="293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2918520" y="2766600"/>
            <a:ext cx="37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H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6200000">
            <a:off x="3053520" y="2752200"/>
            <a:ext cx="403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H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3169080" y="2755440"/>
            <a:ext cx="39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E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3318840" y="2796840"/>
            <a:ext cx="307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3404160" y="2768040"/>
            <a:ext cx="368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H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3529800" y="2754360"/>
            <a:ext cx="400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H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3675600" y="2754360"/>
            <a:ext cx="400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4a H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3882960" y="2802960"/>
            <a:ext cx="293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3987000" y="2766600"/>
            <a:ext cx="3711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H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4109400" y="2752200"/>
            <a:ext cx="403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H18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4233240" y="2752200"/>
            <a:ext cx="4032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500" spc="-1" strike="noStrike">
                <a:solidFill>
                  <a:srgbClr val="000000"/>
                </a:solidFill>
                <a:latin typeface="Times New Roman"/>
              </a:rPr>
              <a:t>36 H24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5">
            <a:lum contrast="6000"/>
          </a:blip>
          <a:srcRect l="71987" t="14117" r="15019" b="25989"/>
          <a:stretch/>
        </p:blipFill>
        <p:spPr>
          <a:xfrm>
            <a:off x="2809800" y="4062240"/>
            <a:ext cx="676440" cy="274320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6"/>
          <a:srcRect l="0" t="14117" r="28487" b="25989"/>
          <a:stretch/>
        </p:blipFill>
        <p:spPr>
          <a:xfrm>
            <a:off x="809640" y="4087800"/>
            <a:ext cx="2019240" cy="2743200"/>
          </a:xfrm>
          <a:prstGeom prst="rect">
            <a:avLst/>
          </a:prstGeom>
          <a:ln w="0">
            <a:noFill/>
          </a:ln>
        </p:spPr>
      </p:pic>
      <p:grpSp>
        <p:nvGrpSpPr>
          <p:cNvPr id="76" name=""/>
          <p:cNvGrpSpPr/>
          <p:nvPr/>
        </p:nvGrpSpPr>
        <p:grpSpPr>
          <a:xfrm>
            <a:off x="1101600" y="3322800"/>
            <a:ext cx="1707840" cy="866520"/>
            <a:chOff x="1101600" y="3322800"/>
            <a:chExt cx="1707840" cy="866520"/>
          </a:xfrm>
        </p:grpSpPr>
        <p:sp>
          <p:nvSpPr>
            <p:cNvPr id="77" name=""/>
            <p:cNvSpPr/>
            <p:nvPr/>
          </p:nvSpPr>
          <p:spPr>
            <a:xfrm rot="16200000">
              <a:off x="986400" y="387936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16200000">
              <a:off x="1092240" y="3778200"/>
              <a:ext cx="633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1290600" y="376092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6200000">
              <a:off x="1508040" y="376092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rot="16200000">
              <a:off x="1978560" y="3792960"/>
              <a:ext cx="60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6200000">
              <a:off x="2178720" y="377388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6200000">
              <a:off x="2396160" y="377388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6200000">
              <a:off x="1870200" y="389376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5400000">
              <a:off x="1875960" y="2737800"/>
              <a:ext cx="108360" cy="1628640"/>
            </a:xfrm>
            <a:custGeom>
              <a:avLst/>
              <a:gdLst>
                <a:gd name="textAreaLeft" fmla="*/ 69120 w 108360"/>
                <a:gd name="textAreaRight" fmla="*/ 108720 w 108360"/>
                <a:gd name="textAreaTop" fmla="*/ 42480 h 1628640"/>
                <a:gd name="textAreaBottom" fmla="*/ 1586160 h 1628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668240" y="332280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7" name="" descr=""/>
          <p:cNvPicPr/>
          <p:nvPr/>
        </p:nvPicPr>
        <p:blipFill>
          <a:blip r:embed="rId7">
            <a:lum contrast="6000"/>
          </a:blip>
          <a:srcRect l="73842" t="13941" r="13468" b="12224"/>
          <a:stretch/>
        </p:blipFill>
        <p:spPr>
          <a:xfrm>
            <a:off x="5667480" y="4057560"/>
            <a:ext cx="619200" cy="313848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8"/>
          <a:srcRect l="0" t="13941" r="26474" b="12224"/>
          <a:stretch/>
        </p:blipFill>
        <p:spPr>
          <a:xfrm>
            <a:off x="3543480" y="4084560"/>
            <a:ext cx="2152440" cy="3138480"/>
          </a:xfrm>
          <a:prstGeom prst="rect">
            <a:avLst/>
          </a:prstGeom>
          <a:ln w="0">
            <a:noFill/>
          </a:ln>
        </p:spPr>
      </p:pic>
      <p:grpSp>
        <p:nvGrpSpPr>
          <p:cNvPr id="89" name=""/>
          <p:cNvGrpSpPr/>
          <p:nvPr/>
        </p:nvGrpSpPr>
        <p:grpSpPr>
          <a:xfrm>
            <a:off x="3959280" y="3322800"/>
            <a:ext cx="1707480" cy="866520"/>
            <a:chOff x="3959280" y="3322800"/>
            <a:chExt cx="1707480" cy="866520"/>
          </a:xfrm>
        </p:grpSpPr>
        <p:sp>
          <p:nvSpPr>
            <p:cNvPr id="90" name=""/>
            <p:cNvSpPr/>
            <p:nvPr/>
          </p:nvSpPr>
          <p:spPr>
            <a:xfrm rot="16200000">
              <a:off x="3844080" y="387936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3949560" y="3778200"/>
              <a:ext cx="633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4147920" y="376092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6200000">
              <a:off x="4365360" y="376092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6200000">
              <a:off x="4835880" y="3792960"/>
              <a:ext cx="60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6200000">
              <a:off x="5036040" y="377388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16200000">
              <a:off x="5253480" y="377388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4727520" y="389376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5400000">
              <a:off x="4732920" y="2738160"/>
              <a:ext cx="108360" cy="1628280"/>
            </a:xfrm>
            <a:custGeom>
              <a:avLst/>
              <a:gdLst>
                <a:gd name="textAreaLeft" fmla="*/ 69120 w 108360"/>
                <a:gd name="textAreaRight" fmla="*/ 108720 w 108360"/>
                <a:gd name="textAreaTop" fmla="*/ 42120 h 1628280"/>
                <a:gd name="textAreaBottom" fmla="*/ 1586160 h 1628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525560" y="332280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"/>
          <p:cNvSpPr/>
          <p:nvPr/>
        </p:nvSpPr>
        <p:spPr>
          <a:xfrm>
            <a:off x="605520" y="33447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462840" y="334476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v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0T10:41:57Z</dcterms:created>
  <dc:creator>John Timms</dc:creator>
  <dc:description/>
  <dc:language>en-US</dc:language>
  <cp:lastModifiedBy>John Timms</cp:lastModifiedBy>
  <dcterms:modified xsi:type="dcterms:W3CDTF">2010-09-10T10:42:20Z</dcterms:modified>
  <cp:revision>1</cp:revision>
  <dc:subject/>
  <dc:title>Slide 1</dc:title>
</cp:coreProperties>
</file>